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FFCC9-A806-4027-9D92-F30BDF6642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65AE6-CA63-4262-AFAB-B32CD52B4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19F70-C7ED-4969-8219-A7084625CE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C6CE2-C5FB-4EB7-BFF3-3A29CF5066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3C538-6D0A-40F4-B218-4D3B91B38F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67E8B-C831-482F-BA9A-4A8C1312BC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C7812-57F3-4205-827A-DA550A2CBF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454A8-AF48-435D-970C-EB21878FB0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3C98B9-651C-4878-874F-3395AED8F5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9E827-CD4F-4FC6-A2EB-2B98A7A84F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E0DAA-5C71-4739-BB09-955E1B204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29D8E-F8F0-42E0-BD24-BD65763222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F63DF6-3DCB-47C0-8596-C8D32474A15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84360" y="620640"/>
          <a:ext cx="7775280" cy="4971960"/>
        </p:xfrm>
        <a:graphic>
          <a:graphicData uri="http://schemas.openxmlformats.org/drawingml/2006/table">
            <a:tbl>
              <a:tblPr/>
              <a:tblGrid>
                <a:gridCol w="863280"/>
                <a:gridCol w="1440000"/>
                <a:gridCol w="4896000"/>
                <a:gridCol w="576000"/>
              </a:tblGrid>
              <a:tr h="174600">
                <a:tc>
                  <a:txBody>
                    <a:bodyPr lIns="1800" rIns="1800" tIns="18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thoge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sequence (5'-3'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ze (b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3480">
                <a:tc rowSpan="27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cter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bri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GAGCGGATAACAATTTCACACCTGGGTAATG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TCGCC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AGGGTTTTCCCAGTCACGGTCTACAGGAC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TAG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typhimuriu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TGATTGCTCTTGAGAGTCCC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1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GCTCTGCCGTAAGAAATGA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enteritid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GAGCGGATAACAATTTCACACGGAGGGAGGAGCTTTAGC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AGGGTTTTCCCAGTCACGCTGGCGAATGGTGAGCA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igel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ATATTCMAGCATC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AGCAAT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GGCAAATGATACTTGACGACTT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2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. diffic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AATGA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CAAG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TT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AAAGAG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TGCAT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W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CCT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. jejun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CATCTTGAGTTGCTCCATAAGAT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GTGCAACTAAACAAGATACTTTTGC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. enterocoliti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GAGCGGATAACAATTTCACACTGGGTATACATTGGATAATGACC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AGGGTTTTCCCAGTCACGCGTATGCCATTGACGTCTTAC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1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P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T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AAGCGAAATGMTGAA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CGACCTGACCAAATG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T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TATGATCACGCGAGAGGAA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TGGGTCTCCTCATTACAAGTAT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A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GATACAACCCCTGTCTGGAA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TAATACAGAATCGTCAGCATCA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1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I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GTTCCGCCTCGAAATTC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TCTTCACGGCTTCTG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H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CATATATCTCAGG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CAC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3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CATATATCTCAGG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TAC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AACTCCATTAACGCCAGATATG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. coli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1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GCTCTGCGGTCCTAGTTAGAA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TTGGCATGACGTTATAGGCTA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rowSpan="1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rus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rovir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GTACCAGAG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K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CA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GATTCAA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W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WD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TGG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CACGAATGA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TAAAG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TTCTGG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CATAA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ATTCTCCCATGGCAGGTG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1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TCTAGAC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ATATGAAGCAAG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tavirus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GAATACACTGATATATACATGGAC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GTTAAAGGATCTGGAGATTTAAA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enovir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ACGGGCACTCTTCGCC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4/5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CAATTCTGAGTTGAAGTTGGT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trovirus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AGGGTTTTCCCAGTCACGCAGAAGAGCAACTCCATC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5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GAGCGGATAACAATTTCACACAG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GTAGC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TT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179280" y="168120"/>
            <a:ext cx="864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b050"/>
                </a:solidFill>
                <a:latin typeface="Times New Roman"/>
                <a:ea typeface="Times New Roman"/>
              </a:rPr>
              <a:t>Table S2. Conventional PCR primer sequences and product size for Sanger sequencing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矩形 4"/>
          <p:cNvSpPr/>
          <p:nvPr/>
        </p:nvSpPr>
        <p:spPr>
          <a:xfrm>
            <a:off x="684360" y="5630760"/>
            <a:ext cx="691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highlighted base corresponds to degenerate bases as follows: K(G/T), W(A/T), Y(C/T), R(A/G) , D(G/T/C)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6-11T01:32:00Z</dcterms:created>
  <dc:creator>pc</dc:creator>
  <dc:description/>
  <dc:language>en-US</dc:language>
  <cp:lastModifiedBy>zhaohu</cp:lastModifiedBy>
  <dcterms:modified xsi:type="dcterms:W3CDTF">2018-07-21T06:19:44Z</dcterms:modified>
  <cp:revision>15</cp:revision>
  <dc:subject/>
  <dc:title>幻灯片 1</dc:title>
</cp:coreProperties>
</file>